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48" d="100"/>
          <a:sy n="48" d="100"/>
        </p:scale>
        <p:origin x="29" y="87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E23C7-FB58-4E2E-B68E-5C4552665D0E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9FAAF7-5350-4094-A30C-4C91E0F87C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29534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E23C7-FB58-4E2E-B68E-5C4552665D0E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9FAAF7-5350-4094-A30C-4C91E0F87C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31062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E23C7-FB58-4E2E-B68E-5C4552665D0E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9FAAF7-5350-4094-A30C-4C91E0F87C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17445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E23C7-FB58-4E2E-B68E-5C4552665D0E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9FAAF7-5350-4094-A30C-4C91E0F87C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17345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E23C7-FB58-4E2E-B68E-5C4552665D0E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9FAAF7-5350-4094-A30C-4C91E0F87C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18133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E23C7-FB58-4E2E-B68E-5C4552665D0E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9FAAF7-5350-4094-A30C-4C91E0F87C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97236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E23C7-FB58-4E2E-B68E-5C4552665D0E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9FAAF7-5350-4094-A30C-4C91E0F87C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97122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E23C7-FB58-4E2E-B68E-5C4552665D0E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9FAAF7-5350-4094-A30C-4C91E0F87C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49619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E23C7-FB58-4E2E-B68E-5C4552665D0E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9FAAF7-5350-4094-A30C-4C91E0F87C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6107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E23C7-FB58-4E2E-B68E-5C4552665D0E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9FAAF7-5350-4094-A30C-4C91E0F87C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98383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E23C7-FB58-4E2E-B68E-5C4552665D0E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9FAAF7-5350-4094-A30C-4C91E0F87C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91363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EE23C7-FB58-4E2E-B68E-5C4552665D0E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9FAAF7-5350-4094-A30C-4C91E0F87C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90088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4" name="Picture 3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53737" y="687977"/>
            <a:ext cx="8999220" cy="5270863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Rectangle 1"/>
          <p:cNvSpPr>
            <a:spLocks noChangeArrowheads="1"/>
          </p:cNvSpPr>
          <p:nvPr/>
        </p:nvSpPr>
        <p:spPr bwMode="auto">
          <a:xfrm>
            <a:off x="673768" y="595884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Figure S7.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Correlation between β-</a:t>
            </a:r>
            <a:r>
              <a:rPr kumimoji="0" lang="en-US" altLang="en-US" sz="1200" b="0" i="0" u="sng" strike="noStrike" cap="none" normalizeH="0" baseline="0" smtClean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haematin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inhibition activity (BIHA</a:t>
            </a:r>
            <a:r>
              <a:rPr kumimoji="0" lang="en-US" altLang="en-US" sz="1200" b="0" i="0" u="none" strike="noStrike" cap="none" normalizeH="0" baseline="-3000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50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, µM) and </a:t>
            </a:r>
            <a:r>
              <a:rPr kumimoji="0" lang="en-US" altLang="en-US" sz="1200" b="0" i="0" u="sng" strike="noStrike" cap="none" normalizeH="0" baseline="0" smtClean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anti-malarial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activity (IC</a:t>
            </a:r>
            <a:r>
              <a:rPr kumimoji="0" lang="en-US" altLang="en-US" sz="1200" b="0" i="0" u="none" strike="noStrike" cap="none" normalizeH="0" baseline="-3000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50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­, µM) for deprotected chloroquinolines against sensitive strain W2</a:t>
            </a: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rPr>
              <a:t> 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426462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8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MS Mincho</vt:lpstr>
      <vt:lpstr>Times New Roman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goc Nguyen</dc:creator>
  <cp:lastModifiedBy>Ngoc Nguyen</cp:lastModifiedBy>
  <cp:revision>2</cp:revision>
  <dcterms:created xsi:type="dcterms:W3CDTF">2020-07-03T15:58:16Z</dcterms:created>
  <dcterms:modified xsi:type="dcterms:W3CDTF">2020-08-04T16:31:51Z</dcterms:modified>
</cp:coreProperties>
</file>